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8CAA87-91EC-44C8-940E-54AE5899D3A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9CA6B5-7C42-4BCB-859E-EE055C2C2D7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A49042-F95E-4C3B-A168-8836C4CFF9E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049398-1881-4FF7-A002-EDFF617C4D1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F77F81-0694-4AFC-83B8-1703815B20D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970C54-B8A8-4E26-B407-D73672EFBFD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5B1361-80DE-4F20-8DFE-B21A7209F5D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98D44B-6674-45F4-98CA-DD543E7908C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B61B8D-4CC7-475A-B833-41F8E9DCB56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EDFFA2-17C7-432C-93F5-E361B2C9BA3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94FA25-8966-4146-8819-ADBF0AAB125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779DD0-26A9-41B2-8A1B-56CE05F4B2D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A0B4227-DF7C-4665-8C08-2428FBB7E126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7"/>
          <p:cNvSpPr/>
          <p:nvPr/>
        </p:nvSpPr>
        <p:spPr>
          <a:xfrm>
            <a:off x="1492200" y="2228760"/>
            <a:ext cx="1143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RPK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 Box 4"/>
          <p:cNvSpPr/>
          <p:nvPr/>
        </p:nvSpPr>
        <p:spPr>
          <a:xfrm>
            <a:off x="0" y="77760"/>
            <a:ext cx="67057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igure S3.  Expression (RPKM) of the signal recognition particle (SRP)  ribonucleoprotein protein-RNA complex, including 7SL (top) and the protein coding components (bottom)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3" name="Chart 9" descr=""/>
          <p:cNvPicPr/>
          <p:nvPr/>
        </p:nvPicPr>
        <p:blipFill>
          <a:blip r:embed="rId1"/>
          <a:stretch/>
        </p:blipFill>
        <p:spPr>
          <a:xfrm>
            <a:off x="2341440" y="1494000"/>
            <a:ext cx="3943440" cy="2633400"/>
          </a:xfrm>
          <a:prstGeom prst="rect">
            <a:avLst/>
          </a:prstGeom>
          <a:ln w="0">
            <a:noFill/>
          </a:ln>
        </p:spPr>
      </p:pic>
      <p:sp>
        <p:nvSpPr>
          <p:cNvPr id="44" name="TextBox 7"/>
          <p:cNvSpPr/>
          <p:nvPr/>
        </p:nvSpPr>
        <p:spPr>
          <a:xfrm>
            <a:off x="1565280" y="5529240"/>
            <a:ext cx="1143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RPK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5" name="Chart 6" descr=""/>
          <p:cNvPicPr/>
          <p:nvPr/>
        </p:nvPicPr>
        <p:blipFill>
          <a:blip r:embed="rId2"/>
          <a:stretch/>
        </p:blipFill>
        <p:spPr>
          <a:xfrm>
            <a:off x="2414520" y="4584600"/>
            <a:ext cx="4046760" cy="30481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8-27T14:29:25Z</dcterms:created>
  <dc:creator>John Castle</dc:creator>
  <dc:description/>
  <dc:language>en-US</dc:language>
  <cp:lastModifiedBy>John Castle</cp:lastModifiedBy>
  <dcterms:modified xsi:type="dcterms:W3CDTF">2010-06-18T07:10:35Z</dcterms:modified>
  <cp:revision>97</cp:revision>
  <dc:subject/>
  <dc:title>Slide 1</dc:title>
</cp:coreProperties>
</file>